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5"/>
  </p:notesMasterIdLst>
  <p:sldIdLst>
    <p:sldId id="301" r:id="rId2"/>
    <p:sldId id="302" r:id="rId3"/>
    <p:sldId id="303" r:id="rId4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schke, Maria" initials="EM" lastIdx="8" clrIdx="0">
    <p:extLst>
      <p:ext uri="{19B8F6BF-5375-455C-9EA6-DF929625EA0E}">
        <p15:presenceInfo xmlns:p15="http://schemas.microsoft.com/office/powerpoint/2012/main" userId="Eschke, Maria" providerId="None"/>
      </p:ext>
    </p:extLst>
  </p:cmAuthor>
  <p:cmAuthor id="2" name="Maria Eschke" initials="ME [2]" lastIdx="10" clrIdx="1">
    <p:extLst>
      <p:ext uri="{19B8F6BF-5375-455C-9EA6-DF929625EA0E}">
        <p15:presenceInfo xmlns:p15="http://schemas.microsoft.com/office/powerpoint/2012/main" userId="Maria Eschke" providerId="None"/>
      </p:ext>
    </p:extLst>
  </p:cmAuthor>
  <p:cmAuthor id="3" name="Maria Eschke" initials="ME" lastIdx="6" clrIdx="2">
    <p:extLst>
      <p:ext uri="{19B8F6BF-5375-455C-9EA6-DF929625EA0E}">
        <p15:presenceInfo xmlns:p15="http://schemas.microsoft.com/office/powerpoint/2012/main" userId="3990a6e585f05a8f" providerId="Windows Live"/>
      </p:ext>
    </p:extLst>
  </p:cmAuthor>
  <p:cmAuthor id="4" name="Eschke, Maria" initials="EM [2]" lastIdx="1" clrIdx="3">
    <p:extLst>
      <p:ext uri="{19B8F6BF-5375-455C-9EA6-DF929625EA0E}">
        <p15:presenceInfo xmlns:p15="http://schemas.microsoft.com/office/powerpoint/2012/main" userId="S-1-5-21-2361800232-213331468-3115616407-125911" providerId="AD"/>
      </p:ext>
    </p:extLst>
  </p:cmAuthor>
  <p:cmAuthor id="5" name="Stefan Keller" initials="SK" lastIdx="2" clrIdx="4">
    <p:extLst>
      <p:ext uri="{19B8F6BF-5375-455C-9EA6-DF929625EA0E}">
        <p15:presenceInfo xmlns:p15="http://schemas.microsoft.com/office/powerpoint/2012/main" userId="Stefan Kell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E61B1D"/>
    <a:srgbClr val="6D409B"/>
    <a:srgbClr val="FB9A9A"/>
    <a:srgbClr val="2DCDCF"/>
    <a:srgbClr val="FF5451"/>
    <a:srgbClr val="7BA073"/>
    <a:srgbClr val="739B6B"/>
    <a:srgbClr val="D40000"/>
    <a:srgbClr val="7092A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697"/>
    <p:restoredTop sz="96327" autoAdjust="0"/>
  </p:normalViewPr>
  <p:slideViewPr>
    <p:cSldViewPr snapToGrid="0" snapToObjects="1">
      <p:cViewPr varScale="1">
        <p:scale>
          <a:sx n="89" d="100"/>
          <a:sy n="89" d="100"/>
        </p:scale>
        <p:origin x="2944" y="16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196B2A-A5DF-E64D-90A1-AF8995343E41}" type="datetimeFigureOut">
              <a:rPr lang="en-US" smtClean="0"/>
              <a:t>12/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486DBC-F850-AF4E-A4F7-589B89B56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802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59627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1pPr>
    <a:lvl2pPr marL="429814" algn="l" defTabSz="859627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2pPr>
    <a:lvl3pPr marL="859627" algn="l" defTabSz="859627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3pPr>
    <a:lvl4pPr marL="1289441" algn="l" defTabSz="859627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4pPr>
    <a:lvl5pPr marL="1719255" algn="l" defTabSz="859627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5pPr>
    <a:lvl6pPr marL="2149069" algn="l" defTabSz="859627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6pPr>
    <a:lvl7pPr marL="2578882" algn="l" defTabSz="859627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7pPr>
    <a:lvl8pPr marL="3008696" algn="l" defTabSz="859627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8pPr>
    <a:lvl9pPr marL="3438510" algn="l" defTabSz="859627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41425"/>
            <a:ext cx="2317750" cy="33496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486DBC-F850-AF4E-A4F7-589B89B56F4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7671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486DBC-F850-AF4E-A4F7-589B89B56F4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124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986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744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746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965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137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648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772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043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665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016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716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9E7CD-CBC8-F146-8407-13C1930F219E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AA34A-FD35-1842-AA46-FB28CD593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538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0F41E75B-0296-3EDF-183A-A1E2959643AE}"/>
              </a:ext>
            </a:extLst>
          </p:cNvPr>
          <p:cNvGrpSpPr/>
          <p:nvPr/>
        </p:nvGrpSpPr>
        <p:grpSpPr>
          <a:xfrm>
            <a:off x="135467" y="625477"/>
            <a:ext cx="6221049" cy="2862790"/>
            <a:chOff x="-16934" y="3409216"/>
            <a:chExt cx="6883401" cy="3167590"/>
          </a:xfrm>
        </p:grpSpPr>
        <p:pic>
          <p:nvPicPr>
            <p:cNvPr id="4" name="Picture 3" descr="A picture containing line, plot, diagram, screenshot&#10;&#10;Description automatically generated">
              <a:extLst>
                <a:ext uri="{FF2B5EF4-FFF2-40B4-BE49-F238E27FC236}">
                  <a16:creationId xmlns:a16="http://schemas.microsoft.com/office/drawing/2014/main" id="{CD4F6818-ACB9-2BBE-4EBD-9289B7242B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467" y="3409216"/>
              <a:ext cx="6858000" cy="1597198"/>
            </a:xfrm>
            <a:prstGeom prst="rect">
              <a:avLst/>
            </a:prstGeom>
          </p:spPr>
        </p:pic>
        <p:pic>
          <p:nvPicPr>
            <p:cNvPr id="7" name="Picture 6" descr="A picture containing text, line, plot, diagram&#10;&#10;Description automatically generated">
              <a:extLst>
                <a:ext uri="{FF2B5EF4-FFF2-40B4-BE49-F238E27FC236}">
                  <a16:creationId xmlns:a16="http://schemas.microsoft.com/office/drawing/2014/main" id="{F10A2438-CF0C-BFCE-07C7-F2E01911D99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16934" y="4989480"/>
              <a:ext cx="6858000" cy="1587326"/>
            </a:xfrm>
            <a:prstGeom prst="rect">
              <a:avLst/>
            </a:prstGeom>
          </p:spPr>
        </p:pic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A7B62382-97D8-1063-9E63-C268455D6B3C}"/>
              </a:ext>
            </a:extLst>
          </p:cNvPr>
          <p:cNvSpPr txBox="1"/>
          <p:nvPr/>
        </p:nvSpPr>
        <p:spPr>
          <a:xfrm>
            <a:off x="158424" y="4039308"/>
            <a:ext cx="655796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1 </a:t>
            </a:r>
            <a:r>
              <a:rPr lang="en-US" dirty="0"/>
              <a:t>Comparing generated anchors and associated runtime (in seconds) with five junctional lengths {48, 51, 54, 57 and 60} under parameter settings of population sizes {100, 250, 500, 750 and 1000}, random material rates {10, 25, 50, 75 and 100} and minimum distance ratios {0.5, 0.6, 0.7, 0.8 and 0.9} across the dataset group ‘MS-Mixed’ with dataset sizes of 10 K, 50 K and 100 K. </a:t>
            </a:r>
          </a:p>
        </p:txBody>
      </p:sp>
    </p:spTree>
    <p:extLst>
      <p:ext uri="{BB962C8B-B14F-4D97-AF65-F5344CB8AC3E}">
        <p14:creationId xmlns:p14="http://schemas.microsoft.com/office/powerpoint/2010/main" val="27206896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>
            <a:extLst>
              <a:ext uri="{FF2B5EF4-FFF2-40B4-BE49-F238E27FC236}">
                <a16:creationId xmlns:a16="http://schemas.microsoft.com/office/drawing/2014/main" id="{2A4BAE9A-EBA7-ABEE-579B-6EA1832854B4}"/>
              </a:ext>
            </a:extLst>
          </p:cNvPr>
          <p:cNvGrpSpPr/>
          <p:nvPr/>
        </p:nvGrpSpPr>
        <p:grpSpPr>
          <a:xfrm>
            <a:off x="113105" y="0"/>
            <a:ext cx="6308529" cy="8406782"/>
            <a:chOff x="0" y="434648"/>
            <a:chExt cx="6310238" cy="9293915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F578E920-F863-9831-D4F7-B5D317505BB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5689" y="686459"/>
              <a:ext cx="6123214" cy="2846161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B3B85AC-F33C-472D-2F83-3B47F4C7F2E4}"/>
                </a:ext>
              </a:extLst>
            </p:cNvPr>
            <p:cNvSpPr txBox="1"/>
            <p:nvPr/>
          </p:nvSpPr>
          <p:spPr>
            <a:xfrm>
              <a:off x="0" y="43464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F0E4741-10E5-CE4A-A50C-4E48F10FD6BF}"/>
                </a:ext>
              </a:extLst>
            </p:cNvPr>
            <p:cNvSpPr txBox="1"/>
            <p:nvPr/>
          </p:nvSpPr>
          <p:spPr>
            <a:xfrm>
              <a:off x="0" y="347386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4DD79BCD-D674-9362-E64A-4080E226231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5689" y="3784431"/>
              <a:ext cx="6123215" cy="2846161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74C8D35D-3D65-1074-B855-3BAF3D1D2A7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75687" y="6882403"/>
              <a:ext cx="6134551" cy="2846160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123BBAF-437E-7520-692D-2160A0855CF3}"/>
                </a:ext>
              </a:extLst>
            </p:cNvPr>
            <p:cNvSpPr txBox="1"/>
            <p:nvPr/>
          </p:nvSpPr>
          <p:spPr>
            <a:xfrm>
              <a:off x="0" y="663059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ED0E0C29-6DCA-87FA-BF90-92B67D21F3B9}"/>
              </a:ext>
            </a:extLst>
          </p:cNvPr>
          <p:cNvSpPr txBox="1"/>
          <p:nvPr/>
        </p:nvSpPr>
        <p:spPr>
          <a:xfrm>
            <a:off x="113105" y="8406782"/>
            <a:ext cx="6516295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. S2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eatmap plots of anchor number and runtime (in seconds) based on random material rates {10, 25, 50, 75 and 100}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x-axis), population sizes {100, 250, 500, 750 and 1000} (y-axis) and minimum distance ratios {0.5, 0.6, 0.7, 0.8 and 0.9}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column) stratified by the dataset group ‘MS-Mixed’ with dataset sizes 10 K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A),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50 K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B)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nd 100 K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C)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Values represent average over five junctional lengths {48, 51, 54, 57 and 60}.</a:t>
            </a:r>
            <a:endParaRPr lang="en-CA" sz="14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69339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diagram of different colored boxes&#10;&#10;Description automatically generated with medium confidence">
            <a:extLst>
              <a:ext uri="{FF2B5EF4-FFF2-40B4-BE49-F238E27FC236}">
                <a16:creationId xmlns:a16="http://schemas.microsoft.com/office/drawing/2014/main" id="{0612138B-4140-D096-0372-6F33257C4BF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92" y="621030"/>
            <a:ext cx="6805615" cy="272224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E88FCAD-790F-6FF6-ECA8-37A1F832926A}"/>
              </a:ext>
            </a:extLst>
          </p:cNvPr>
          <p:cNvSpPr txBox="1"/>
          <p:nvPr/>
        </p:nvSpPr>
        <p:spPr>
          <a:xfrm>
            <a:off x="120251" y="3671888"/>
            <a:ext cx="661749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3 </a:t>
            </a:r>
            <a:r>
              <a:rPr lang="en-US" dirty="0"/>
              <a:t>Clustering performance (F-measure, precision and sensitivity) of 40 simulated MS datasets (M2, M3, M4, and M5) was evaluated between </a:t>
            </a:r>
            <a:r>
              <a:rPr lang="en-US" dirty="0" err="1"/>
              <a:t>DefineClones</a:t>
            </a:r>
            <a:r>
              <a:rPr lang="en-US" dirty="0"/>
              <a:t> and Anchor Clustering. </a:t>
            </a:r>
          </a:p>
        </p:txBody>
      </p:sp>
    </p:spTree>
    <p:extLst>
      <p:ext uri="{BB962C8B-B14F-4D97-AF65-F5344CB8AC3E}">
        <p14:creationId xmlns:p14="http://schemas.microsoft.com/office/powerpoint/2010/main" val="3126890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219</TotalTime>
  <Words>246</Words>
  <Application>Microsoft Macintosh PowerPoint</Application>
  <PresentationFormat>A4 Paper (210x297 mm)</PresentationFormat>
  <Paragraphs>8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 Keller</dc:creator>
  <cp:lastModifiedBy>Haiyang Chang</cp:lastModifiedBy>
  <cp:revision>453</cp:revision>
  <cp:lastPrinted>2022-09-15T07:16:57Z</cp:lastPrinted>
  <dcterms:created xsi:type="dcterms:W3CDTF">2022-02-08T09:26:11Z</dcterms:created>
  <dcterms:modified xsi:type="dcterms:W3CDTF">2023-12-03T16:41:11Z</dcterms:modified>
</cp:coreProperties>
</file>